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D73E1-F3C4-4B37-80A1-B2F8A5265E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04B86-3669-4567-9770-C05CB023D9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D49C2-6008-4B82-B056-28DD4E613E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11C8D-89C9-4A36-81F0-1CF6363467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1AD29-5893-4AEF-ADFE-04370E7CBD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8B701-F543-4BA7-B7FB-482687B9B6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6F623-94CA-4924-AEE4-3E79354A6F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E03BD-8752-49F5-B20E-B6C1196C3B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9A452-AAF6-4208-A3D3-F74CEDD292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39756-5DC1-472E-9E66-DF08FA3787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6B202-D43E-49BA-827B-DB7E97DF6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00D71-6A8E-48EA-91C0-1B8F37809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4ADD50-46FC-4C09-B8FB-8ACC4AA201A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4600" y="4876920"/>
            <a:ext cx="5956200" cy="246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1. VEGF-D antibody used in immunodepletion experiments fails to recognize VEGF-A or VEGF-C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ditioned concentrated medium from untreated SUM-149 or SUM-190 cells was immunodepleted using a rabbit anti-VEGF-D antibody (sc-25784) (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VD) or control normal rabbit IgG (sc-2027) (Ctrl), both purchased from Santa Cruz Biotechnology. Immunodepleted media were used in Western blot analysis with mouse monoclonal antibodies VEGF-A (MAB293) and VEGF-C (MAB752) [R&amp;D Systems]. Alternatively, the media were assessed for VEGF-D (Fig. 5B). For each cell line, a representative of two independent experiments is shown. Values given below are averages relative to control sample set to 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± S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om two independent experiments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cept for VEGF-A in SUM-149 cells, which is from a single experiment as VEGF-A was below detectable levels in the repeat experi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478240" y="3314880"/>
            <a:ext cx="1600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.0   1.0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± 0.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441520" y="2835360"/>
            <a:ext cx="152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.0   0.9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55800" y="25970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EGF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855800" y="312912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EGF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44760" y="2131920"/>
            <a:ext cx="16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UM-1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rcRect l="0" t="1444" r="0" b="2817"/>
          <a:stretch/>
        </p:blipFill>
        <p:spPr>
          <a:xfrm>
            <a:off x="2495520" y="2560680"/>
            <a:ext cx="608040" cy="3128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48" name="" descr=""/>
          <p:cNvPicPr/>
          <p:nvPr/>
        </p:nvPicPr>
        <p:blipFill>
          <a:blip r:embed="rId2"/>
          <a:srcRect l="1692" t="5072" r="627" b="3486"/>
          <a:stretch/>
        </p:blipFill>
        <p:spPr>
          <a:xfrm>
            <a:off x="2494080" y="3106800"/>
            <a:ext cx="614160" cy="2430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49" name=""/>
          <p:cNvSpPr/>
          <p:nvPr/>
        </p:nvSpPr>
        <p:spPr>
          <a:xfrm>
            <a:off x="2706120" y="23130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V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434320" y="231444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41680" y="2131920"/>
            <a:ext cx="16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SUM-1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3"/>
          <a:srcRect l="0" t="-1428" r="0" b="1008"/>
          <a:stretch/>
        </p:blipFill>
        <p:spPr>
          <a:xfrm>
            <a:off x="3589200" y="2560680"/>
            <a:ext cx="617760" cy="31428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53" name=""/>
          <p:cNvSpPr/>
          <p:nvPr/>
        </p:nvSpPr>
        <p:spPr>
          <a:xfrm>
            <a:off x="3576600" y="2835360"/>
            <a:ext cx="1600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.0    0.95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± 0.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544920" y="3314880"/>
            <a:ext cx="1600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.0    0.97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± 0.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4"/>
          <a:srcRect l="708" t="1710" r="708" b="3420"/>
          <a:stretch/>
        </p:blipFill>
        <p:spPr>
          <a:xfrm>
            <a:off x="3591000" y="3105000"/>
            <a:ext cx="615960" cy="2448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56" name=""/>
          <p:cNvSpPr/>
          <p:nvPr/>
        </p:nvSpPr>
        <p:spPr>
          <a:xfrm>
            <a:off x="3817080" y="23144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V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45640" y="231300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4T19:29:17Z</dcterms:created>
  <dc:creator> G</dc:creator>
  <dc:description/>
  <dc:language>en-US</dc:language>
  <cp:lastModifiedBy>gsonen01</cp:lastModifiedBy>
  <dcterms:modified xsi:type="dcterms:W3CDTF">2013-07-01T21:46:49Z</dcterms:modified>
  <cp:revision>35</cp:revision>
  <dc:subject/>
  <dc:title>Slide 1</dc:title>
</cp:coreProperties>
</file>